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275497265035346E-2"/>
          <c:y val="2.5890397071957328E-2"/>
          <c:w val="0.78353551837470048"/>
          <c:h val="0.789761450662855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Genus (%)'!$A$2</c:f>
              <c:strCache>
                <c:ptCount val="1"/>
                <c:pt idx="0">
                  <c:v>k__Archaea;p__Euryarchaeota;c__Methanobacteria;o__Methanobacteriales;f__Methanobacteriaceae;g__Methanobrevibact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Genus (%)'!$B$1:$R$1</c:f>
              <c:strCache>
                <c:ptCount val="16"/>
                <c:pt idx="0">
                  <c:v>Hl_1</c:v>
                </c:pt>
                <c:pt idx="1">
                  <c:v>Hl_2</c:v>
                </c:pt>
                <c:pt idx="2">
                  <c:v>Hl_3</c:v>
                </c:pt>
                <c:pt idx="3">
                  <c:v>Hl_5</c:v>
                </c:pt>
                <c:pt idx="4">
                  <c:v>Hl_6</c:v>
                </c:pt>
                <c:pt idx="5">
                  <c:v>Hl_11</c:v>
                </c:pt>
                <c:pt idx="6">
                  <c:v>Pp_1</c:v>
                </c:pt>
                <c:pt idx="7">
                  <c:v>Pp_2</c:v>
                </c:pt>
                <c:pt idx="8">
                  <c:v>Pp_3</c:v>
                </c:pt>
                <c:pt idx="9">
                  <c:v>Pp_4</c:v>
                </c:pt>
                <c:pt idx="10">
                  <c:v>Pp_5</c:v>
                </c:pt>
                <c:pt idx="11">
                  <c:v>Ss_1</c:v>
                </c:pt>
                <c:pt idx="12">
                  <c:v>Ss_2</c:v>
                </c:pt>
                <c:pt idx="13">
                  <c:v>Ss_3</c:v>
                </c:pt>
                <c:pt idx="14">
                  <c:v>Ss_4</c:v>
                </c:pt>
                <c:pt idx="15">
                  <c:v>Ss_5</c:v>
                </c:pt>
              </c:strCache>
            </c:strRef>
          </c:cat>
          <c:val>
            <c:numRef>
              <c:f>'Genus (%)'!$B$2:$R$2</c:f>
              <c:numCache>
                <c:formatCode>General</c:formatCode>
                <c:ptCount val="16"/>
                <c:pt idx="0">
                  <c:v>0.55254400468825204</c:v>
                </c:pt>
                <c:pt idx="1">
                  <c:v>0.51283116020264097</c:v>
                </c:pt>
                <c:pt idx="2">
                  <c:v>0.235945453869877</c:v>
                </c:pt>
                <c:pt idx="3">
                  <c:v>0.22687966079631</c:v>
                </c:pt>
                <c:pt idx="4">
                  <c:v>0.26709834075273198</c:v>
                </c:pt>
                <c:pt idx="5">
                  <c:v>0.13450536127003401</c:v>
                </c:pt>
                <c:pt idx="6">
                  <c:v>1.0578929489979101</c:v>
                </c:pt>
                <c:pt idx="7">
                  <c:v>0.93127882127994599</c:v>
                </c:pt>
                <c:pt idx="8">
                  <c:v>0.95715135885737002</c:v>
                </c:pt>
                <c:pt idx="9">
                  <c:v>0.58929383614467401</c:v>
                </c:pt>
                <c:pt idx="10">
                  <c:v>0.104979688712401</c:v>
                </c:pt>
                <c:pt idx="11">
                  <c:v>0.29695751907107398</c:v>
                </c:pt>
                <c:pt idx="12">
                  <c:v>0.124902205690599</c:v>
                </c:pt>
                <c:pt idx="13">
                  <c:v>7.7128324856166094E-2</c:v>
                </c:pt>
                <c:pt idx="14">
                  <c:v>0.354338914750226</c:v>
                </c:pt>
                <c:pt idx="15">
                  <c:v>0.920649817881164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14-4099-B2BD-70943A3518E9}"/>
            </c:ext>
          </c:extLst>
        </c:ser>
        <c:ser>
          <c:idx val="1"/>
          <c:order val="1"/>
          <c:tx>
            <c:strRef>
              <c:f>'Genus (%)'!$A$3</c:f>
              <c:strCache>
                <c:ptCount val="1"/>
                <c:pt idx="0">
                  <c:v>k__Archaea;p__Euryarchaeota;c__Methanobacteria;o__Methanobacteriales;f__Methanobacteriaceae;g__Methanosphaer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Genus (%)'!$B$1:$R$1</c:f>
              <c:strCache>
                <c:ptCount val="16"/>
                <c:pt idx="0">
                  <c:v>Hl_1</c:v>
                </c:pt>
                <c:pt idx="1">
                  <c:v>Hl_2</c:v>
                </c:pt>
                <c:pt idx="2">
                  <c:v>Hl_3</c:v>
                </c:pt>
                <c:pt idx="3">
                  <c:v>Hl_5</c:v>
                </c:pt>
                <c:pt idx="4">
                  <c:v>Hl_6</c:v>
                </c:pt>
                <c:pt idx="5">
                  <c:v>Hl_11</c:v>
                </c:pt>
                <c:pt idx="6">
                  <c:v>Pp_1</c:v>
                </c:pt>
                <c:pt idx="7">
                  <c:v>Pp_2</c:v>
                </c:pt>
                <c:pt idx="8">
                  <c:v>Pp_3</c:v>
                </c:pt>
                <c:pt idx="9">
                  <c:v>Pp_4</c:v>
                </c:pt>
                <c:pt idx="10">
                  <c:v>Pp_5</c:v>
                </c:pt>
                <c:pt idx="11">
                  <c:v>Ss_1</c:v>
                </c:pt>
                <c:pt idx="12">
                  <c:v>Ss_2</c:v>
                </c:pt>
                <c:pt idx="13">
                  <c:v>Ss_3</c:v>
                </c:pt>
                <c:pt idx="14">
                  <c:v>Ss_4</c:v>
                </c:pt>
                <c:pt idx="15">
                  <c:v>Ss_5</c:v>
                </c:pt>
              </c:strCache>
            </c:strRef>
          </c:cat>
          <c:val>
            <c:numRef>
              <c:f>'Genus (%)'!$B$3:$R$3</c:f>
              <c:numCache>
                <c:formatCode>General</c:formatCode>
                <c:ptCount val="16"/>
                <c:pt idx="0">
                  <c:v>1.67437577178258E-2</c:v>
                </c:pt>
                <c:pt idx="1">
                  <c:v>3.52960717548376E-2</c:v>
                </c:pt>
                <c:pt idx="2">
                  <c:v>2.97254115111656E-2</c:v>
                </c:pt>
                <c:pt idx="3">
                  <c:v>5.5790080523682901E-3</c:v>
                </c:pt>
                <c:pt idx="4">
                  <c:v>1.21408336705787E-2</c:v>
                </c:pt>
                <c:pt idx="5">
                  <c:v>5.6833251240859303E-3</c:v>
                </c:pt>
                <c:pt idx="6">
                  <c:v>3.6395399621487801E-2</c:v>
                </c:pt>
                <c:pt idx="7">
                  <c:v>2.2494657518839301E-3</c:v>
                </c:pt>
                <c:pt idx="8">
                  <c:v>5.4552668121404503E-2</c:v>
                </c:pt>
                <c:pt idx="9">
                  <c:v>3.3617433605568597E-2</c:v>
                </c:pt>
                <c:pt idx="10">
                  <c:v>2.7386005751061201E-2</c:v>
                </c:pt>
                <c:pt idx="11">
                  <c:v>5.3345662108576202E-3</c:v>
                </c:pt>
                <c:pt idx="12">
                  <c:v>1.37255171088571E-3</c:v>
                </c:pt>
                <c:pt idx="13">
                  <c:v>4.1690986408738397E-3</c:v>
                </c:pt>
                <c:pt idx="14">
                  <c:v>4.6318812385650401E-3</c:v>
                </c:pt>
                <c:pt idx="15">
                  <c:v>3.12842171124668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214-4099-B2BD-70943A3518E9}"/>
            </c:ext>
          </c:extLst>
        </c:ser>
        <c:ser>
          <c:idx val="2"/>
          <c:order val="2"/>
          <c:tx>
            <c:strRef>
              <c:f>'Genus (%)'!$A$4</c:f>
              <c:strCache>
                <c:ptCount val="1"/>
                <c:pt idx="0">
                  <c:v>k__Archaea;p__Euryarchaeota;c__Thermoplasmata;o__Methanomassiliicoccales;f__Methanomethylophilaceae;g__uncultur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Genus (%)'!$B$1:$R$1</c:f>
              <c:strCache>
                <c:ptCount val="16"/>
                <c:pt idx="0">
                  <c:v>Hl_1</c:v>
                </c:pt>
                <c:pt idx="1">
                  <c:v>Hl_2</c:v>
                </c:pt>
                <c:pt idx="2">
                  <c:v>Hl_3</c:v>
                </c:pt>
                <c:pt idx="3">
                  <c:v>Hl_5</c:v>
                </c:pt>
                <c:pt idx="4">
                  <c:v>Hl_6</c:v>
                </c:pt>
                <c:pt idx="5">
                  <c:v>Hl_11</c:v>
                </c:pt>
                <c:pt idx="6">
                  <c:v>Pp_1</c:v>
                </c:pt>
                <c:pt idx="7">
                  <c:v>Pp_2</c:v>
                </c:pt>
                <c:pt idx="8">
                  <c:v>Pp_3</c:v>
                </c:pt>
                <c:pt idx="9">
                  <c:v>Pp_4</c:v>
                </c:pt>
                <c:pt idx="10">
                  <c:v>Pp_5</c:v>
                </c:pt>
                <c:pt idx="11">
                  <c:v>Ss_1</c:v>
                </c:pt>
                <c:pt idx="12">
                  <c:v>Ss_2</c:v>
                </c:pt>
                <c:pt idx="13">
                  <c:v>Ss_3</c:v>
                </c:pt>
                <c:pt idx="14">
                  <c:v>Ss_4</c:v>
                </c:pt>
                <c:pt idx="15">
                  <c:v>Ss_5</c:v>
                </c:pt>
              </c:strCache>
            </c:strRef>
          </c:cat>
          <c:val>
            <c:numRef>
              <c:f>'Genus (%)'!$B$4:$R$4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2.7451034217714199E-3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214-4099-B2BD-70943A3518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13321360"/>
        <c:axId val="413320944"/>
      </c:barChart>
      <c:catAx>
        <c:axId val="413321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13320944"/>
        <c:crosses val="autoZero"/>
        <c:auto val="1"/>
        <c:lblAlgn val="ctr"/>
        <c:lblOffset val="100"/>
        <c:noMultiLvlLbl val="0"/>
      </c:catAx>
      <c:valAx>
        <c:axId val="4133209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1400" dirty="0" smtClean="0"/>
                  <a:t>Relative abundance, %</a:t>
                </a:r>
                <a:endParaRPr lang="zh-TW" altLang="en-US" sz="1400" dirty="0"/>
              </a:p>
            </c:rich>
          </c:tx>
          <c:layout>
            <c:manualLayout>
              <c:xMode val="edge"/>
              <c:yMode val="edge"/>
              <c:x val="5.2996721158238471E-3"/>
              <c:y val="0.260633086000041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TW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1332136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3.8000874654547621E-2"/>
          <c:y val="0.87731398898740731"/>
          <c:w val="0.86491511344080307"/>
          <c:h val="0.115624993629331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6023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837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434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2850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5249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38925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37560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25192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62036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10399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0066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334A21-A732-47AC-BD58-2CEFDFD8F9D6}" type="datetimeFigureOut">
              <a:rPr lang="zh-TW" altLang="en-US" smtClean="0"/>
              <a:t>2022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32055-6807-4B87-818B-54D2BE0C4E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7119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群組 11"/>
          <p:cNvGrpSpPr/>
          <p:nvPr/>
        </p:nvGrpSpPr>
        <p:grpSpPr>
          <a:xfrm>
            <a:off x="1824133" y="143407"/>
            <a:ext cx="7189124" cy="5395823"/>
            <a:chOff x="1350307" y="852991"/>
            <a:chExt cx="7189124" cy="5395823"/>
          </a:xfrm>
        </p:grpSpPr>
        <p:graphicFrame>
          <p:nvGraphicFramePr>
            <p:cNvPr id="2" name="圖表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34797295"/>
                </p:ext>
              </p:extLst>
            </p:nvPr>
          </p:nvGraphicFramePr>
          <p:xfrm>
            <a:off x="1350307" y="852991"/>
            <a:ext cx="7189124" cy="53958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6" name="直線接點 5"/>
            <p:cNvCxnSpPr/>
            <p:nvPr/>
          </p:nvCxnSpPr>
          <p:spPr>
            <a:xfrm flipV="1">
              <a:off x="4040136" y="995363"/>
              <a:ext cx="48470" cy="4253562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接點 7"/>
            <p:cNvCxnSpPr/>
            <p:nvPr/>
          </p:nvCxnSpPr>
          <p:spPr>
            <a:xfrm flipH="1" flipV="1">
              <a:off x="5767388" y="995363"/>
              <a:ext cx="6057" cy="4253562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矩形 2"/>
          <p:cNvSpPr/>
          <p:nvPr/>
        </p:nvSpPr>
        <p:spPr>
          <a:xfrm>
            <a:off x="2083724" y="5577509"/>
            <a:ext cx="637863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/>
              <a:t>Figure S1. The relative abundance of archaea in the gut microbiota of white-handed gibbons (Hl), Bornean orangutan (Pp) and </a:t>
            </a:r>
            <a:r>
              <a:rPr lang="en-US" altLang="zh-TW" sz="1200" dirty="0" err="1"/>
              <a:t>Siamangs</a:t>
            </a:r>
            <a:r>
              <a:rPr lang="en-US" altLang="zh-TW" sz="1200" dirty="0"/>
              <a:t> (</a:t>
            </a:r>
            <a:r>
              <a:rPr lang="en-US" altLang="zh-TW" sz="1200" dirty="0" err="1"/>
              <a:t>Ss</a:t>
            </a:r>
            <a:r>
              <a:rPr lang="en-US" altLang="zh-TW" sz="1200" dirty="0"/>
              <a:t>). </a:t>
            </a:r>
            <a:endParaRPr lang="zh-TW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910998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群組 5"/>
          <p:cNvGrpSpPr/>
          <p:nvPr/>
        </p:nvGrpSpPr>
        <p:grpSpPr>
          <a:xfrm>
            <a:off x="2766041" y="649858"/>
            <a:ext cx="5812693" cy="2963808"/>
            <a:chOff x="1203249" y="427785"/>
            <a:chExt cx="9279100" cy="4286250"/>
          </a:xfrm>
        </p:grpSpPr>
        <p:pic>
          <p:nvPicPr>
            <p:cNvPr id="2" name="圖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03249" y="427785"/>
              <a:ext cx="4762819" cy="4286250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67875" y="427785"/>
              <a:ext cx="4914474" cy="4286250"/>
            </a:xfrm>
            <a:prstGeom prst="rect">
              <a:avLst/>
            </a:prstGeom>
          </p:spPr>
        </p:pic>
      </p:grpSp>
      <p:sp>
        <p:nvSpPr>
          <p:cNvPr id="5" name="矩形 4"/>
          <p:cNvSpPr/>
          <p:nvPr/>
        </p:nvSpPr>
        <p:spPr>
          <a:xfrm>
            <a:off x="2926417" y="3613666"/>
            <a:ext cx="32587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dirty="0"/>
              <a:t>Figure S2. Rarefactions of 16 sequenced samples.</a:t>
            </a:r>
            <a:endParaRPr lang="zh-TW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7916031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 descr="UPGMA clustering tree based on Weighted Unifrac distance.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1180" y="1355565"/>
            <a:ext cx="3188166" cy="36273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文字方塊 9"/>
          <p:cNvSpPr txBox="1"/>
          <p:nvPr/>
        </p:nvSpPr>
        <p:spPr>
          <a:xfrm>
            <a:off x="6841375" y="960885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</a:t>
            </a:r>
            <a:r>
              <a:rPr lang="en-US" altLang="zh-TW" dirty="0" smtClean="0"/>
              <a:t>S3B</a:t>
            </a:r>
            <a:endParaRPr lang="zh-TW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2085155" y="5213456"/>
            <a:ext cx="82641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dirty="0"/>
              <a:t>Figure </a:t>
            </a:r>
            <a:r>
              <a:rPr lang="en-US" altLang="zh-TW" sz="1200" dirty="0" smtClean="0"/>
              <a:t>S3</a:t>
            </a:r>
            <a:r>
              <a:rPr lang="en-US" altLang="zh-TW" sz="1200" dirty="0"/>
              <a:t>. Beta-diversity analysis of fecal microbiome of white-handed gibbons, Bornean orangutans and </a:t>
            </a:r>
            <a:r>
              <a:rPr lang="en-US" altLang="zh-TW" sz="1200" dirty="0" err="1"/>
              <a:t>siamangs</a:t>
            </a:r>
            <a:r>
              <a:rPr lang="en-US" altLang="zh-TW" sz="1200" dirty="0"/>
              <a:t>. The diversity of samples was analyzed by (</a:t>
            </a:r>
            <a:r>
              <a:rPr lang="en-US" altLang="zh-TW" sz="1200" dirty="0" smtClean="0"/>
              <a:t>A) </a:t>
            </a:r>
            <a:r>
              <a:rPr lang="en-US" altLang="zh-TW" sz="1200" dirty="0" smtClean="0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Principal </a:t>
            </a:r>
            <a:r>
              <a:rPr lang="en-US" altLang="zh-TW" sz="1200" dirty="0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coordinates analysis (</a:t>
            </a:r>
            <a:r>
              <a:rPr lang="en-US" altLang="zh-TW" sz="1200" dirty="0" err="1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PCoA</a:t>
            </a:r>
            <a:r>
              <a:rPr lang="en-US" altLang="zh-TW" sz="1200" dirty="0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) plot. </a:t>
            </a:r>
            <a:r>
              <a:rPr lang="en-US" altLang="zh-TW" sz="1200" dirty="0" smtClean="0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altLang="zh-TW" sz="1200" dirty="0" smtClean="0"/>
              <a:t>B</a:t>
            </a:r>
            <a:r>
              <a:rPr lang="en-US" altLang="zh-TW" sz="1200" dirty="0" smtClean="0"/>
              <a:t>) </a:t>
            </a:r>
            <a:r>
              <a:rPr lang="en-US" altLang="zh-TW" sz="1200" dirty="0"/>
              <a:t>Unweighted Pair Group Method with Arithmetic mean (UPGMA) clustering, of White-handed gibbons (Hl, n=6), Bornean orangutans (Pp, n=5), and </a:t>
            </a:r>
            <a:r>
              <a:rPr lang="en-US" altLang="zh-TW" sz="1200" dirty="0" err="1"/>
              <a:t>Siamang</a:t>
            </a:r>
            <a:r>
              <a:rPr lang="en-US" altLang="zh-TW" sz="1200" dirty="0"/>
              <a:t> (</a:t>
            </a:r>
            <a:r>
              <a:rPr lang="en-US" altLang="zh-TW" sz="1200" dirty="0" err="1"/>
              <a:t>Ss</a:t>
            </a:r>
            <a:r>
              <a:rPr lang="en-US" altLang="zh-TW" sz="1200" dirty="0"/>
              <a:t>, n=5). </a:t>
            </a:r>
            <a:endParaRPr lang="zh-TW" altLang="en-US" sz="1200" dirty="0"/>
          </a:p>
        </p:txBody>
      </p:sp>
      <p:grpSp>
        <p:nvGrpSpPr>
          <p:cNvPr id="12" name="群組 11"/>
          <p:cNvGrpSpPr/>
          <p:nvPr/>
        </p:nvGrpSpPr>
        <p:grpSpPr>
          <a:xfrm>
            <a:off x="1245326" y="960885"/>
            <a:ext cx="5753990" cy="4137292"/>
            <a:chOff x="1860469" y="77551"/>
            <a:chExt cx="7283531" cy="5325722"/>
          </a:xfrm>
        </p:grpSpPr>
        <p:grpSp>
          <p:nvGrpSpPr>
            <p:cNvPr id="13" name="群組 12">
              <a:extLst>
                <a:ext uri="{FF2B5EF4-FFF2-40B4-BE49-F238E27FC236}">
                  <a16:creationId xmlns:a16="http://schemas.microsoft.com/office/drawing/2014/main" id="{9CCFC9C1-D69D-4122-8FDB-D968B2513A14}"/>
                </a:ext>
              </a:extLst>
            </p:cNvPr>
            <p:cNvGrpSpPr/>
            <p:nvPr/>
          </p:nvGrpSpPr>
          <p:grpSpPr>
            <a:xfrm>
              <a:off x="2211185" y="378595"/>
              <a:ext cx="6932815" cy="5024678"/>
              <a:chOff x="2093904" y="1247554"/>
              <a:chExt cx="8273947" cy="4362892"/>
            </a:xfrm>
          </p:grpSpPr>
          <p:grpSp>
            <p:nvGrpSpPr>
              <p:cNvPr id="15" name="群組 14">
                <a:extLst>
                  <a:ext uri="{FF2B5EF4-FFF2-40B4-BE49-F238E27FC236}">
                    <a16:creationId xmlns:a16="http://schemas.microsoft.com/office/drawing/2014/main" id="{1F80BF5B-8E73-48CD-ACE3-CAE16E6FC59E}"/>
                  </a:ext>
                </a:extLst>
              </p:cNvPr>
              <p:cNvGrpSpPr/>
              <p:nvPr/>
            </p:nvGrpSpPr>
            <p:grpSpPr>
              <a:xfrm>
                <a:off x="2093904" y="1247554"/>
                <a:ext cx="7680962" cy="4362892"/>
                <a:chOff x="1129203" y="763518"/>
                <a:chExt cx="9610364" cy="5330962"/>
              </a:xfrm>
            </p:grpSpPr>
            <p:grpSp>
              <p:nvGrpSpPr>
                <p:cNvPr id="20" name="群組 19">
                  <a:extLst>
                    <a:ext uri="{FF2B5EF4-FFF2-40B4-BE49-F238E27FC236}">
                      <a16:creationId xmlns:a16="http://schemas.microsoft.com/office/drawing/2014/main" id="{5857DE71-212F-43D5-AADF-62ACACEECBBB}"/>
                    </a:ext>
                  </a:extLst>
                </p:cNvPr>
                <p:cNvGrpSpPr/>
                <p:nvPr/>
              </p:nvGrpSpPr>
              <p:grpSpPr>
                <a:xfrm>
                  <a:off x="1129203" y="763518"/>
                  <a:ext cx="9610364" cy="5330962"/>
                  <a:chOff x="1129203" y="763518"/>
                  <a:chExt cx="9610364" cy="5330962"/>
                </a:xfrm>
              </p:grpSpPr>
              <p:pic>
                <p:nvPicPr>
                  <p:cNvPr id="24" name="圖片 23">
                    <a:extLst>
                      <a:ext uri="{FF2B5EF4-FFF2-40B4-BE49-F238E27FC236}">
                        <a16:creationId xmlns:a16="http://schemas.microsoft.com/office/drawing/2014/main" id="{F809DF50-18A4-41B7-80B8-4BF2DAFD42C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29203" y="763518"/>
                    <a:ext cx="9610364" cy="5330962"/>
                  </a:xfrm>
                  <a:prstGeom prst="rect">
                    <a:avLst/>
                  </a:prstGeom>
                </p:spPr>
              </p:pic>
              <p:sp>
                <p:nvSpPr>
                  <p:cNvPr id="25" name="矩形 24">
                    <a:extLst>
                      <a:ext uri="{FF2B5EF4-FFF2-40B4-BE49-F238E27FC236}">
                        <a16:creationId xmlns:a16="http://schemas.microsoft.com/office/drawing/2014/main" id="{59B19E4C-E5B2-48C1-8A70-B56C7E024D10}"/>
                      </a:ext>
                    </a:extLst>
                  </p:cNvPr>
                  <p:cNvSpPr/>
                  <p:nvPr/>
                </p:nvSpPr>
                <p:spPr>
                  <a:xfrm>
                    <a:off x="5852668" y="2185156"/>
                    <a:ext cx="850900" cy="314325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TW" altLang="en-US"/>
                  </a:p>
                </p:txBody>
              </p:sp>
            </p:grpSp>
            <p:pic>
              <p:nvPicPr>
                <p:cNvPr id="21" name="圖片 20">
                  <a:extLst>
                    <a:ext uri="{FF2B5EF4-FFF2-40B4-BE49-F238E27FC236}">
                      <a16:creationId xmlns:a16="http://schemas.microsoft.com/office/drawing/2014/main" id="{114AA458-FC68-440D-B317-9BB2DE61F5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3603" t="25177" r="44427" b="73966"/>
                <a:stretch/>
              </p:blipFill>
              <p:spPr>
                <a:xfrm rot="10800000">
                  <a:off x="6315738" y="2185156"/>
                  <a:ext cx="189355" cy="45719"/>
                </a:xfrm>
                <a:prstGeom prst="rect">
                  <a:avLst/>
                </a:prstGeom>
              </p:spPr>
            </p:pic>
            <p:pic>
              <p:nvPicPr>
                <p:cNvPr id="22" name="圖片 21">
                  <a:extLst>
                    <a:ext uri="{FF2B5EF4-FFF2-40B4-BE49-F238E27FC236}">
                      <a16:creationId xmlns:a16="http://schemas.microsoft.com/office/drawing/2014/main" id="{99967EB9-EFEC-415A-82EF-37697AB8C3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3184" t="34818" r="42748" b="61933"/>
                <a:stretch/>
              </p:blipFill>
              <p:spPr>
                <a:xfrm>
                  <a:off x="6096000" y="2296473"/>
                  <a:ext cx="390940" cy="173177"/>
                </a:xfrm>
                <a:prstGeom prst="rect">
                  <a:avLst/>
                </a:prstGeom>
              </p:spPr>
            </p:pic>
            <p:pic>
              <p:nvPicPr>
                <p:cNvPr id="23" name="圖片 22">
                  <a:extLst>
                    <a:ext uri="{FF2B5EF4-FFF2-40B4-BE49-F238E27FC236}">
                      <a16:creationId xmlns:a16="http://schemas.microsoft.com/office/drawing/2014/main" id="{8D86FD0C-3CF2-4C6D-A54D-8BC71C19EA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3363" t="74895" r="43244" b="21856"/>
                <a:stretch/>
              </p:blipFill>
              <p:spPr>
                <a:xfrm>
                  <a:off x="6505093" y="3824578"/>
                  <a:ext cx="326004" cy="173177"/>
                </a:xfrm>
                <a:prstGeom prst="rect">
                  <a:avLst/>
                </a:prstGeom>
              </p:spPr>
            </p:pic>
          </p:grpSp>
          <p:sp>
            <p:nvSpPr>
              <p:cNvPr id="16" name="橢圓 15">
                <a:extLst>
                  <a:ext uri="{FF2B5EF4-FFF2-40B4-BE49-F238E27FC236}">
                    <a16:creationId xmlns:a16="http://schemas.microsoft.com/office/drawing/2014/main" id="{09979CE0-6946-48BA-BC4F-C49824C93FE1}"/>
                  </a:ext>
                </a:extLst>
              </p:cNvPr>
              <p:cNvSpPr/>
              <p:nvPr/>
            </p:nvSpPr>
            <p:spPr>
              <a:xfrm>
                <a:off x="7429427" y="2502135"/>
                <a:ext cx="2040862" cy="1392340"/>
              </a:xfrm>
              <a:prstGeom prst="ellipse">
                <a:avLst/>
              </a:prstGeom>
              <a:solidFill>
                <a:srgbClr val="00B0F0">
                  <a:alpha val="10196"/>
                </a:srgbClr>
              </a:solidFill>
              <a:ln w="381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7" name="橢圓 16">
                <a:extLst>
                  <a:ext uri="{FF2B5EF4-FFF2-40B4-BE49-F238E27FC236}">
                    <a16:creationId xmlns:a16="http://schemas.microsoft.com/office/drawing/2014/main" id="{B053EC50-DEE5-4884-8F1E-B30CA7835F6B}"/>
                  </a:ext>
                </a:extLst>
              </p:cNvPr>
              <p:cNvSpPr/>
              <p:nvPr/>
            </p:nvSpPr>
            <p:spPr>
              <a:xfrm rot="3000000">
                <a:off x="4636747" y="2951019"/>
                <a:ext cx="2906927" cy="1464261"/>
              </a:xfrm>
              <a:prstGeom prst="ellipse">
                <a:avLst/>
              </a:prstGeom>
              <a:solidFill>
                <a:srgbClr val="FFFF00">
                  <a:alpha val="10196"/>
                </a:srgbClr>
              </a:solidFill>
              <a:ln w="381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/>
              </a:p>
            </p:txBody>
          </p:sp>
          <p:sp>
            <p:nvSpPr>
              <p:cNvPr id="18" name="橢圓 17">
                <a:extLst>
                  <a:ext uri="{FF2B5EF4-FFF2-40B4-BE49-F238E27FC236}">
                    <a16:creationId xmlns:a16="http://schemas.microsoft.com/office/drawing/2014/main" id="{75E24C2A-A9CC-46A4-AA16-260876DB5DA2}"/>
                  </a:ext>
                </a:extLst>
              </p:cNvPr>
              <p:cNvSpPr/>
              <p:nvPr/>
            </p:nvSpPr>
            <p:spPr>
              <a:xfrm rot="4472417">
                <a:off x="3115432" y="3742667"/>
                <a:ext cx="1912028" cy="573285"/>
              </a:xfrm>
              <a:prstGeom prst="ellipse">
                <a:avLst/>
              </a:prstGeom>
              <a:solidFill>
                <a:srgbClr val="7030A0">
                  <a:alpha val="10196"/>
                </a:srgbClr>
              </a:solidFill>
              <a:ln w="381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pic>
            <p:nvPicPr>
              <p:cNvPr id="19" name="圖片 18">
                <a:extLst>
                  <a:ext uri="{FF2B5EF4-FFF2-40B4-BE49-F238E27FC236}">
                    <a16:creationId xmlns:a16="http://schemas.microsoft.com/office/drawing/2014/main" id="{976C747F-74C6-4B48-8A56-3645DCB0E8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501" t="26844" r="42356" b="15098"/>
              <a:stretch/>
            </p:blipFill>
            <p:spPr>
              <a:xfrm>
                <a:off x="9760951" y="1904300"/>
                <a:ext cx="606900" cy="2400210"/>
              </a:xfrm>
              <a:prstGeom prst="rect">
                <a:avLst/>
              </a:prstGeom>
              <a:solidFill>
                <a:schemeClr val="bg1"/>
              </a:solidFill>
            </p:spPr>
          </p:pic>
        </p:grpSp>
        <p:sp>
          <p:nvSpPr>
            <p:cNvPr id="14" name="文字方塊 13"/>
            <p:cNvSpPr txBox="1"/>
            <p:nvPr/>
          </p:nvSpPr>
          <p:spPr>
            <a:xfrm>
              <a:off x="1860469" y="77551"/>
              <a:ext cx="1487994" cy="4890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 smtClean="0"/>
                <a:t>Figure </a:t>
              </a:r>
              <a:r>
                <a:rPr lang="en-US" altLang="zh-TW" dirty="0" smtClean="0"/>
                <a:t>S3A</a:t>
              </a:r>
              <a:endParaRPr lang="zh-TW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823057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17</Words>
  <Application>Microsoft Office PowerPoint</Application>
  <PresentationFormat>寬螢幕</PresentationFormat>
  <Paragraphs>6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4</cp:revision>
  <dcterms:created xsi:type="dcterms:W3CDTF">2022-04-09T13:07:10Z</dcterms:created>
  <dcterms:modified xsi:type="dcterms:W3CDTF">2022-06-08T09:30:12Z</dcterms:modified>
</cp:coreProperties>
</file>